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9" d="100"/>
          <a:sy n="69" d="100"/>
        </p:scale>
        <p:origin x="672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E6F4-4330-4A6B-AD25-FD1B54E2A4A2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EAC74-6667-472E-BA43-C6D1316B5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5607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E6F4-4330-4A6B-AD25-FD1B54E2A4A2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EAC74-6667-472E-BA43-C6D1316B5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5335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E6F4-4330-4A6B-AD25-FD1B54E2A4A2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EAC74-6667-472E-BA43-C6D1316B5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137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E6F4-4330-4A6B-AD25-FD1B54E2A4A2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EAC74-6667-472E-BA43-C6D1316B5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5949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E6F4-4330-4A6B-AD25-FD1B54E2A4A2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EAC74-6667-472E-BA43-C6D1316B5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4783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E6F4-4330-4A6B-AD25-FD1B54E2A4A2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EAC74-6667-472E-BA43-C6D1316B5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2695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E6F4-4330-4A6B-AD25-FD1B54E2A4A2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EAC74-6667-472E-BA43-C6D1316B5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2069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E6F4-4330-4A6B-AD25-FD1B54E2A4A2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EAC74-6667-472E-BA43-C6D1316B5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0405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E6F4-4330-4A6B-AD25-FD1B54E2A4A2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EAC74-6667-472E-BA43-C6D1316B5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4603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E6F4-4330-4A6B-AD25-FD1B54E2A4A2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EAC74-6667-472E-BA43-C6D1316B5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158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E6F4-4330-4A6B-AD25-FD1B54E2A4A2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EAC74-6667-472E-BA43-C6D1316B5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7194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ECE6F4-4330-4A6B-AD25-FD1B54E2A4A2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2EAC74-6667-472E-BA43-C6D1316B5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2433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565282" y="4387071"/>
            <a:ext cx="9061436" cy="16767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b="1" dirty="0" smtClean="0"/>
              <a:t>Supplementary Figure3 </a:t>
            </a:r>
            <a:r>
              <a:rPr lang="en-US" altLang="zh-CN" dirty="0" smtClean="0"/>
              <a:t>The </a:t>
            </a:r>
            <a:r>
              <a:rPr lang="en-US" altLang="zh-CN" dirty="0" err="1" smtClean="0"/>
              <a:t>immunohistochemical</a:t>
            </a:r>
            <a:r>
              <a:rPr lang="en-US" altLang="zh-CN" dirty="0" smtClean="0"/>
              <a:t> images showed the expression of Ngn3 in Non-T2DM and T2DM patients. n=3 in each group. Ngn3, Neurogenin3; T2DM, Type 2 Diabetic Mellitus.</a:t>
            </a:r>
            <a:endParaRPr lang="zh-CN" altLang="en-US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709" y="570041"/>
            <a:ext cx="8856629" cy="3108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7138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2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>chin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2</cp:revision>
  <dcterms:created xsi:type="dcterms:W3CDTF">2018-09-19T01:40:37Z</dcterms:created>
  <dcterms:modified xsi:type="dcterms:W3CDTF">2018-09-19T01:45:32Z</dcterms:modified>
</cp:coreProperties>
</file>